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6"/>
  </p:notesMasterIdLst>
  <p:sldIdLst>
    <p:sldId id="261" r:id="rId3"/>
    <p:sldId id="256" r:id="rId4"/>
    <p:sldId id="262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782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1.xml"/><Relationship Id="rId7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3.xml"/><Relationship Id="rId10" Type="http://schemas.openxmlformats.org/officeDocument/2006/relationships/tableStyles" Target="tableStyles.xml"/><Relationship Id="rId4" Type="http://schemas.openxmlformats.org/officeDocument/2006/relationships/slide" Target="slides/slide2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AAAC2B-0FC9-4582-9207-1467558C704A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4573F3-9B0A-4BB1-A30D-0652F04856A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8714435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CCF170D1-D079-5242-ACF0-D2BB5EF5636B}" type="slidenum">
              <a:rPr kumimoji="0" lang="de-DE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de-DE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382580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2F974F-F013-4FE9-AD30-AC3C4FD5140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3E6113A3-03E5-893D-01B5-DA99D976F2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43065C1-A73D-9676-B089-1FFE12D991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CFC5CA7-7182-FC06-450B-E7CD912EAE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B74CE96-2CC1-CA7E-7296-447508A3DE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8790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8126C39-6E91-D2DE-38DA-C90B01FFE8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DE82304-9C14-37DC-09E3-5CCB26C2CB5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C75D824-DEEF-9EA6-D3D0-84BEFEEC6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F13C17E-11A1-D20D-DBA0-2A7618EDD2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A6A53C0-BA44-0203-3450-834DC2505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26988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4B087F0-281F-6F88-D6A9-06053C4EF3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9CA6155-62F1-4237-A902-1ED60D91B0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B956328-2C63-633F-7C8B-C937D3952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0D2CF8F-EF36-A794-96DA-2457FDAC33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BC8F0F78-02B7-98BE-FC20-4776D45909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575326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36869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9087176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933804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1211278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055729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701625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9600394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23339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BA7A629-33BC-A155-66A7-DEBD605EDA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43EA8415-9F13-3CD2-AD20-A60D472591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EC31476-D574-E05A-45AD-306CA601AC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98E0E1C-6394-EF1B-97C5-C699DC89C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583934B-31CD-D240-3AFC-8372C11D6A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6698218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487283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7865434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99230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44A5BE8-9966-30E6-3DC5-B464A9A268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6DB2C30-63A2-5259-D903-176FDC80C2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293775-DD4D-AA1C-69D7-D912118450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EBD7595-CB9F-76DD-22AC-DDEDFA79F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6BEB752-34B3-991C-235D-AEA809B12B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1112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A6C0F96-1CEE-34EE-E3D8-8B99780FD6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0B2AA56-5DBB-C188-28CA-52469031C6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760CB58D-A879-74DC-9274-1BBEC1B478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BD91E8C-29FB-73F5-288C-6F9400C90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15EB41A-A545-F54E-387D-B8601B4EC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C18D45C-8DB3-375D-4022-5A705785AF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62313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ECCD996-ADE4-6F67-1C11-72564C02F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BEEEDBE-3BE0-6C10-2D62-2888D30B79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3BCBA7D-9799-0A10-CCF1-5EF18377605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683528D-8D1B-D3D0-A565-BB48E5B86F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B3C899A7-1B1C-BFB1-F938-734F357024B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DF503262-B295-40FE-42A2-A1A682D81D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516E872-2E64-B37D-26A7-8EC33A46F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164A20D-F82C-F7BB-703E-A7780960E1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2941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5994D8-60A1-EA0B-F654-A4164F1EFD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5BCDCB4-D53C-E1A4-0BE7-EA8E2F7D7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18C4F5F-F654-7059-9623-C74084AB76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786E702-77AB-2A8B-2D6C-6662ECDE8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5990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3410E7D-84E3-7BBF-631C-6A56772B82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FB3AC75B-3F76-B46E-1331-FA6941C877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75830FD4-F334-4C44-8110-4712E4E8F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3358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6150F0-5B43-0801-A1B1-85336F533F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486CE92-BBB2-3C6B-C4F2-97BE6110FCB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73A35EC7-A5DE-F098-BBDC-F2B53504B4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29E93614-04BA-0115-22BC-279C2BF60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FAFDF4F-A5DE-5643-300E-BF27404DFA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E8B56C0-88E0-4A42-5F94-FB83E41C09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60003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A4B853B-8E14-B18F-6D84-E90FC3E99C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29748714-3DF6-7821-F53B-36CD11AB89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B6BC552-B288-7982-E5C2-999BF45350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1DE499D-AD5D-6931-D9EF-8C22A3364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E23DDD51-9BFF-5F45-6A19-30CBF70E7A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5130CF9-488A-8B6E-72FF-C3308A1E35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58791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BBD1C5E0-0725-D15A-012B-B034F8C82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3D5B2E2-CEA5-5BAD-3D12-AE843EBB58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400460A-EAB6-FAC1-69BC-96F2619E665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861A07-D923-4DDB-85BA-6266A29DBDD3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40A565F-DF3C-4521-710F-9893650B5D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761DD0FB-2105-0469-4E91-A2821CDF92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79BABD-620C-4C3B-BD5B-41B59CB0A7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3159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BED0C-4B8C-DF4C-89E2-456D1318D190}" type="datetimeFigureOut">
              <a:rPr lang="de-DE" smtClean="0"/>
              <a:t>26.07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E0F2DF-EE08-0A43-8600-0EE7A0F0688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918336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5" name="Gruppieren 44">
            <a:extLst>
              <a:ext uri="{FF2B5EF4-FFF2-40B4-BE49-F238E27FC236}">
                <a16:creationId xmlns:a16="http://schemas.microsoft.com/office/drawing/2014/main" id="{1A7F1B84-711F-6312-B03E-59CC93BC7E9D}"/>
              </a:ext>
            </a:extLst>
          </p:cNvPr>
          <p:cNvGrpSpPr/>
          <p:nvPr/>
        </p:nvGrpSpPr>
        <p:grpSpPr>
          <a:xfrm>
            <a:off x="1534942" y="15630"/>
            <a:ext cx="6834202" cy="6826740"/>
            <a:chOff x="10942" y="15630"/>
            <a:chExt cx="6834202" cy="6826740"/>
          </a:xfrm>
        </p:grpSpPr>
        <p:sp>
          <p:nvSpPr>
            <p:cNvPr id="6" name="Abgerundetes Rechteck 5">
              <a:extLst>
                <a:ext uri="{FF2B5EF4-FFF2-40B4-BE49-F238E27FC236}">
                  <a16:creationId xmlns:a16="http://schemas.microsoft.com/office/drawing/2014/main" id="{BB174B7A-1590-1349-8A51-52BA74B5B48D}"/>
                </a:ext>
              </a:extLst>
            </p:cNvPr>
            <p:cNvSpPr/>
            <p:nvPr/>
          </p:nvSpPr>
          <p:spPr>
            <a:xfrm>
              <a:off x="573077" y="935964"/>
              <a:ext cx="2450266" cy="42617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insufficient</a:t>
              </a: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 imaging follow-up </a:t>
              </a:r>
            </a:p>
            <a:p>
              <a:pPr defTabSz="457200" eaLnBrk="0" fontAlgn="base" hangingPunct="0"/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540)</a:t>
              </a:r>
              <a:endParaRPr lang="de-DE" sz="11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7" name="Gerade Verbindung mit Pfeil 6">
              <a:extLst>
                <a:ext uri="{FF2B5EF4-FFF2-40B4-BE49-F238E27FC236}">
                  <a16:creationId xmlns:a16="http://schemas.microsoft.com/office/drawing/2014/main" id="{B821A1D7-FA0A-B14C-9308-AA893AFC86B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12872" y="1088815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0" name="Gerade Verbindung mit Pfeil 19">
              <a:extLst>
                <a:ext uri="{FF2B5EF4-FFF2-40B4-BE49-F238E27FC236}">
                  <a16:creationId xmlns:a16="http://schemas.microsoft.com/office/drawing/2014/main" id="{8DCD7CFD-F6AF-7944-8A10-A7B01A28D424}"/>
                </a:ext>
              </a:extLst>
            </p:cNvPr>
            <p:cNvCxnSpPr>
              <a:cxnSpLocks/>
            </p:cNvCxnSpPr>
            <p:nvPr/>
          </p:nvCxnSpPr>
          <p:spPr>
            <a:xfrm>
              <a:off x="301342" y="876408"/>
              <a:ext cx="23529" cy="433519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Abgerundetes Rechteck 21">
              <a:extLst>
                <a:ext uri="{FF2B5EF4-FFF2-40B4-BE49-F238E27FC236}">
                  <a16:creationId xmlns:a16="http://schemas.microsoft.com/office/drawing/2014/main" id="{3082BB43-5E54-BF4B-85FE-1121C989B194}"/>
                </a:ext>
              </a:extLst>
            </p:cNvPr>
            <p:cNvSpPr/>
            <p:nvPr/>
          </p:nvSpPr>
          <p:spPr>
            <a:xfrm>
              <a:off x="15630" y="15630"/>
              <a:ext cx="3007713" cy="866151"/>
            </a:xfrm>
            <a:prstGeom prst="roundRect">
              <a:avLst/>
            </a:prstGeom>
            <a:noFill/>
            <a:ln w="12700" cap="flat" cmpd="sng" algn="ctr">
              <a:solidFill>
                <a:schemeClr val="tx1"/>
              </a:solidFill>
              <a:prstDash val="solid"/>
              <a:miter lim="800000"/>
            </a:ln>
            <a:effectLst/>
          </p:spPr>
          <p:txBody>
            <a:bodyPr wrap="square"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Patients with malignancy and aneurysm between January 2003 and March 2020 in institutional PACS database</a:t>
              </a:r>
            </a:p>
            <a:p>
              <a:pPr defTabSz="457200" eaLnBrk="0" fontAlgn="base" hangingPunct="0"/>
              <a:endParaRPr lang="en-US" sz="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endParaRPr>
            </a:p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 = 1412</a:t>
              </a:r>
              <a:endParaRPr lang="de-DE" sz="1200" dirty="0">
                <a:solidFill>
                  <a:prstClr val="black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24" name="Gerade Verbindung mit Pfeil 23">
              <a:extLst>
                <a:ext uri="{FF2B5EF4-FFF2-40B4-BE49-F238E27FC236}">
                  <a16:creationId xmlns:a16="http://schemas.microsoft.com/office/drawing/2014/main" id="{B821A1D7-FA0A-B14C-9308-AA893AFC86B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12872" y="1621337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25" name="Abgerundetes Rechteck 24">
              <a:extLst>
                <a:ext uri="{FF2B5EF4-FFF2-40B4-BE49-F238E27FC236}">
                  <a16:creationId xmlns:a16="http://schemas.microsoft.com/office/drawing/2014/main" id="{BB174B7A-1590-1349-8A51-52BA74B5B48D}"/>
                </a:ext>
              </a:extLst>
            </p:cNvPr>
            <p:cNvSpPr/>
            <p:nvPr/>
          </p:nvSpPr>
          <p:spPr>
            <a:xfrm>
              <a:off x="573077" y="1410397"/>
              <a:ext cx="2450266" cy="42617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inadequate aneurysm site </a:t>
              </a:r>
            </a:p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439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26" name="Gerade Verbindung mit Pfeil 25">
              <a:extLst>
                <a:ext uri="{FF2B5EF4-FFF2-40B4-BE49-F238E27FC236}">
                  <a16:creationId xmlns:a16="http://schemas.microsoft.com/office/drawing/2014/main" id="{B821A1D7-FA0A-B14C-9308-AA893AFC86B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12872" y="2105764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27" name="Abgerundetes Rechteck 26">
              <a:extLst>
                <a:ext uri="{FF2B5EF4-FFF2-40B4-BE49-F238E27FC236}">
                  <a16:creationId xmlns:a16="http://schemas.microsoft.com/office/drawing/2014/main" id="{BB174B7A-1590-1349-8A51-52BA74B5B48D}"/>
                </a:ext>
              </a:extLst>
            </p:cNvPr>
            <p:cNvSpPr/>
            <p:nvPr/>
          </p:nvSpPr>
          <p:spPr>
            <a:xfrm>
              <a:off x="573077" y="1894824"/>
              <a:ext cx="2450266" cy="42617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o aneurysm verified</a:t>
              </a:r>
            </a:p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20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28" name="Gerade Verbindung mit Pfeil 27">
              <a:extLst>
                <a:ext uri="{FF2B5EF4-FFF2-40B4-BE49-F238E27FC236}">
                  <a16:creationId xmlns:a16="http://schemas.microsoft.com/office/drawing/2014/main" id="{B821A1D7-FA0A-B14C-9308-AA893AFC86B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03608" y="2588046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29" name="Abgerundetes Rechteck 28">
              <a:extLst>
                <a:ext uri="{FF2B5EF4-FFF2-40B4-BE49-F238E27FC236}">
                  <a16:creationId xmlns:a16="http://schemas.microsoft.com/office/drawing/2014/main" id="{BB174B7A-1590-1349-8A51-52BA74B5B48D}"/>
                </a:ext>
              </a:extLst>
            </p:cNvPr>
            <p:cNvSpPr/>
            <p:nvPr/>
          </p:nvSpPr>
          <p:spPr>
            <a:xfrm>
              <a:off x="563813" y="2377106"/>
              <a:ext cx="2459530" cy="42617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previous aneurysm intervention</a:t>
              </a:r>
            </a:p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118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30" name="Abgerundetes Rechteck 29">
              <a:extLst>
                <a:ext uri="{FF2B5EF4-FFF2-40B4-BE49-F238E27FC236}">
                  <a16:creationId xmlns:a16="http://schemas.microsoft.com/office/drawing/2014/main" id="{BB174B7A-1590-1349-8A51-52BA74B5B48D}"/>
                </a:ext>
              </a:extLst>
            </p:cNvPr>
            <p:cNvSpPr/>
            <p:nvPr/>
          </p:nvSpPr>
          <p:spPr>
            <a:xfrm>
              <a:off x="563813" y="2855314"/>
              <a:ext cx="2459530" cy="42617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incomplete oncologic record</a:t>
              </a:r>
            </a:p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18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31" name="Gerade Verbindung mit Pfeil 30">
              <a:extLst>
                <a:ext uri="{FF2B5EF4-FFF2-40B4-BE49-F238E27FC236}">
                  <a16:creationId xmlns:a16="http://schemas.microsoft.com/office/drawing/2014/main" id="{B821A1D7-FA0A-B14C-9308-AA893AFC86B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01863" y="3067084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2" name="Abgerundetes Rechteck 31">
              <a:extLst>
                <a:ext uri="{FF2B5EF4-FFF2-40B4-BE49-F238E27FC236}">
                  <a16:creationId xmlns:a16="http://schemas.microsoft.com/office/drawing/2014/main" id="{BB174B7A-1590-1349-8A51-52BA74B5B48D}"/>
                </a:ext>
              </a:extLst>
            </p:cNvPr>
            <p:cNvSpPr/>
            <p:nvPr/>
          </p:nvSpPr>
          <p:spPr>
            <a:xfrm>
              <a:off x="563813" y="3329748"/>
              <a:ext cx="2459530" cy="441372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o overlap between aneurysm and cancer diagnosis (n = 60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33" name="Gerade Verbindung mit Pfeil 32">
              <a:extLst>
                <a:ext uri="{FF2B5EF4-FFF2-40B4-BE49-F238E27FC236}">
                  <a16:creationId xmlns:a16="http://schemas.microsoft.com/office/drawing/2014/main" id="{B821A1D7-FA0A-B14C-9308-AA893AFC86B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12872" y="3577394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18" name="Abgerundetes Rechteck 17">
              <a:extLst>
                <a:ext uri="{FF2B5EF4-FFF2-40B4-BE49-F238E27FC236}">
                  <a16:creationId xmlns:a16="http://schemas.microsoft.com/office/drawing/2014/main" id="{B93B67D3-286B-FF41-AB19-9F8E1B0339D0}"/>
                </a:ext>
              </a:extLst>
            </p:cNvPr>
            <p:cNvSpPr/>
            <p:nvPr/>
          </p:nvSpPr>
          <p:spPr>
            <a:xfrm>
              <a:off x="575847" y="4287375"/>
              <a:ext cx="3007712" cy="377936"/>
            </a:xfrm>
            <a:prstGeom prst="round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/>
            <a:lstStyle/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o radiotherapy -&gt; no-RT control</a:t>
              </a:r>
            </a:p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 = 62 </a:t>
              </a:r>
              <a:r>
                <a:rPr lang="en-US" sz="1200" i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AAA + cancer w/o RT 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Table 1-4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)</a:t>
              </a:r>
            </a:p>
          </p:txBody>
        </p:sp>
        <p:sp>
          <p:nvSpPr>
            <p:cNvPr id="35" name="Abgerundetes Rechteck 34">
              <a:extLst>
                <a:ext uri="{FF2B5EF4-FFF2-40B4-BE49-F238E27FC236}">
                  <a16:creationId xmlns:a16="http://schemas.microsoft.com/office/drawing/2014/main" id="{B93B67D3-286B-FF41-AB19-9F8E1B0339D0}"/>
                </a:ext>
              </a:extLst>
            </p:cNvPr>
            <p:cNvSpPr/>
            <p:nvPr/>
          </p:nvSpPr>
          <p:spPr>
            <a:xfrm>
              <a:off x="3277854" y="5211598"/>
              <a:ext cx="3567290" cy="551427"/>
            </a:xfrm>
            <a:prstGeom prst="roundRect">
              <a:avLst/>
            </a:prstGeom>
            <a:solidFill>
              <a:schemeClr val="bg2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/>
            <a:lstStyle/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External reference cohort (Vienna &amp; Stockholm)</a:t>
              </a:r>
            </a:p>
            <a:p>
              <a:pPr algn="ctr" defTabSz="457200" eaLnBrk="0" fontAlgn="base" hangingPunct="0"/>
              <a:endParaRPr lang="en-US" sz="600" dirty="0">
                <a:solidFill>
                  <a:srgbClr val="000000"/>
                </a:solidFill>
                <a:latin typeface="Arial" panose="020B0604020202020204" pitchFamily="34" charset="0"/>
                <a:ea typeface="MS Mincho" panose="02020609040205080304" pitchFamily="49" charset="-128"/>
              </a:endParaRPr>
            </a:p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 = 158 </a:t>
              </a:r>
              <a:r>
                <a:rPr lang="en-US" sz="1200" i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on-cancer AAA 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Table 1-4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)</a:t>
              </a:r>
            </a:p>
          </p:txBody>
        </p:sp>
        <p:cxnSp>
          <p:nvCxnSpPr>
            <p:cNvPr id="5" name="Gerade Verbindung mit Pfeil 4"/>
            <p:cNvCxnSpPr>
              <a:cxnSpLocks/>
            </p:cNvCxnSpPr>
            <p:nvPr/>
          </p:nvCxnSpPr>
          <p:spPr>
            <a:xfrm flipH="1">
              <a:off x="3456879" y="5759371"/>
              <a:ext cx="11152" cy="53157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 Verbindung mit Pfeil 35"/>
            <p:cNvCxnSpPr>
              <a:cxnSpLocks/>
            </p:cNvCxnSpPr>
            <p:nvPr/>
          </p:nvCxnSpPr>
          <p:spPr>
            <a:xfrm>
              <a:off x="3456879" y="4665311"/>
              <a:ext cx="0" cy="546287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Gerade Verbindung mit Pfeil 3">
              <a:extLst>
                <a:ext uri="{FF2B5EF4-FFF2-40B4-BE49-F238E27FC236}">
                  <a16:creationId xmlns:a16="http://schemas.microsoft.com/office/drawing/2014/main" id="{087D3E92-A5D2-C309-4B6C-C5B12CB47D4C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24871" y="4052269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8" name="Abgerundetes Rechteck 24">
              <a:extLst>
                <a:ext uri="{FF2B5EF4-FFF2-40B4-BE49-F238E27FC236}">
                  <a16:creationId xmlns:a16="http://schemas.microsoft.com/office/drawing/2014/main" id="{33DD7E0E-3DD9-FF2D-618D-43D00BA9C627}"/>
                </a:ext>
              </a:extLst>
            </p:cNvPr>
            <p:cNvSpPr/>
            <p:nvPr/>
          </p:nvSpPr>
          <p:spPr>
            <a:xfrm>
              <a:off x="568389" y="3828067"/>
              <a:ext cx="2450266" cy="396852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aneurysm other than AAA</a:t>
              </a:r>
            </a:p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73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9" name="Abgerundetes Rechteck 17">
              <a:extLst>
                <a:ext uri="{FF2B5EF4-FFF2-40B4-BE49-F238E27FC236}">
                  <a16:creationId xmlns:a16="http://schemas.microsoft.com/office/drawing/2014/main" id="{03A76474-8088-920E-B613-A5DE2F290186}"/>
                </a:ext>
              </a:extLst>
            </p:cNvPr>
            <p:cNvSpPr/>
            <p:nvPr/>
          </p:nvSpPr>
          <p:spPr>
            <a:xfrm>
              <a:off x="10942" y="5199844"/>
              <a:ext cx="3007713" cy="551427"/>
            </a:xfrm>
            <a:prstGeom prst="round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/>
            <a:lstStyle/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well-documented RT</a:t>
              </a:r>
            </a:p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 = 38 </a:t>
              </a:r>
              <a:r>
                <a:rPr lang="en-US" sz="1200" i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AAA + cancer + RT 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Table 1-4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)</a:t>
              </a:r>
            </a:p>
          </p:txBody>
        </p:sp>
        <p:sp>
          <p:nvSpPr>
            <p:cNvPr id="10" name="Abgerundetes Rechteck 24">
              <a:extLst>
                <a:ext uri="{FF2B5EF4-FFF2-40B4-BE49-F238E27FC236}">
                  <a16:creationId xmlns:a16="http://schemas.microsoft.com/office/drawing/2014/main" id="{8DFB2135-9AB4-0254-3CEC-EC5972FCEAD7}"/>
                </a:ext>
              </a:extLst>
            </p:cNvPr>
            <p:cNvSpPr/>
            <p:nvPr/>
          </p:nvSpPr>
          <p:spPr>
            <a:xfrm>
              <a:off x="568605" y="4721062"/>
              <a:ext cx="2450266" cy="426171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radiation plans unavailable</a:t>
              </a:r>
            </a:p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n = 44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cxnSp>
          <p:nvCxnSpPr>
            <p:cNvPr id="12" name="Gerade Verbindung mit Pfeil 11">
              <a:extLst>
                <a:ext uri="{FF2B5EF4-FFF2-40B4-BE49-F238E27FC236}">
                  <a16:creationId xmlns:a16="http://schemas.microsoft.com/office/drawing/2014/main" id="{AF1BC1C9-B95C-A21F-8E02-EE8EF43DBF84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297760" y="4511538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13" name="Gerade Verbindung mit Pfeil 12">
              <a:extLst>
                <a:ext uri="{FF2B5EF4-FFF2-40B4-BE49-F238E27FC236}">
                  <a16:creationId xmlns:a16="http://schemas.microsoft.com/office/drawing/2014/main" id="{7FD46D12-E26C-120C-071A-4EE7636BBEC3}"/>
                </a:ext>
              </a:extLst>
            </p:cNvPr>
            <p:cNvCxnSpPr>
              <a:cxnSpLocks/>
            </p:cNvCxnSpPr>
            <p:nvPr/>
          </p:nvCxnSpPr>
          <p:spPr bwMode="auto">
            <a:xfrm flipV="1">
              <a:off x="309105" y="4989956"/>
              <a:ext cx="266742" cy="2146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" name="Gerade Verbindung mit Pfeil 22">
              <a:extLst>
                <a:ext uri="{FF2B5EF4-FFF2-40B4-BE49-F238E27FC236}">
                  <a16:creationId xmlns:a16="http://schemas.microsoft.com/office/drawing/2014/main" id="{B591675B-0512-F073-F909-328E50248F0B}"/>
                </a:ext>
              </a:extLst>
            </p:cNvPr>
            <p:cNvCxnSpPr>
              <a:cxnSpLocks/>
            </p:cNvCxnSpPr>
            <p:nvPr/>
          </p:nvCxnSpPr>
          <p:spPr>
            <a:xfrm>
              <a:off x="3148362" y="4665311"/>
              <a:ext cx="0" cy="1625632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mit Pfeil 18">
              <a:extLst>
                <a:ext uri="{FF2B5EF4-FFF2-40B4-BE49-F238E27FC236}">
                  <a16:creationId xmlns:a16="http://schemas.microsoft.com/office/drawing/2014/main" id="{73F3CB61-F1AF-5C1E-88B2-A5333C38B897}"/>
                </a:ext>
              </a:extLst>
            </p:cNvPr>
            <p:cNvCxnSpPr>
              <a:cxnSpLocks/>
              <a:endCxn id="37" idx="1"/>
            </p:cNvCxnSpPr>
            <p:nvPr/>
          </p:nvCxnSpPr>
          <p:spPr bwMode="auto">
            <a:xfrm>
              <a:off x="324871" y="6017660"/>
              <a:ext cx="254744" cy="2210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1" name="Gerade Verbindung mit Pfeil 20">
              <a:extLst>
                <a:ext uri="{FF2B5EF4-FFF2-40B4-BE49-F238E27FC236}">
                  <a16:creationId xmlns:a16="http://schemas.microsoft.com/office/drawing/2014/main" id="{3725D56A-1948-520A-FD66-B39EE97786BD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324871" y="5763025"/>
              <a:ext cx="0" cy="527918"/>
            </a:xfrm>
            <a:prstGeom prst="straightConnector1">
              <a:avLst/>
            </a:prstGeom>
            <a:solidFill>
              <a:schemeClr val="accent1"/>
            </a:solidFill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wpc="http://schemas.microsoft.com/office/word/2010/wordprocessingCanvas" xmlns:cx="http://schemas.microsoft.com/office/drawing/2014/chartex" xmlns:cx1="http://schemas.microsoft.com/office/drawing/2015/9/8/chartex" xmlns:cx2="http://schemas.microsoft.com/office/drawing/2015/10/21/chartex" xmlns:cx3="http://schemas.microsoft.com/office/drawing/2016/5/9/chartex" xmlns:cx4="http://schemas.microsoft.com/office/drawing/2016/5/10/chartex" xmlns:cx5="http://schemas.microsoft.com/office/drawing/2016/5/11/chartex" xmlns:cx6="http://schemas.microsoft.com/office/drawing/2016/5/12/chartex" xmlns:cx7="http://schemas.microsoft.com/office/drawing/2016/5/13/chartex" xmlns:cx8="http://schemas.microsoft.com/office/drawing/2016/5/14/chartex" xmlns:mc="http://schemas.openxmlformats.org/markup-compatibility/2006" xmlns:aink="http://schemas.microsoft.com/office/drawing/2016/ink" xmlns:am3d="http://schemas.microsoft.com/office/drawing/2017/model3d" xmlns:m="http://schemas.openxmlformats.org/officeDocument/2006/math" xmlns:wp14="http://schemas.microsoft.com/office/word/2010/wordprocessingDrawing" xmlns:wp="http://schemas.openxmlformats.org/drawingml/2006/wordprocessingDrawing" xmlns:w14="http://schemas.microsoft.com/office/word/2010/wordml" xmlns:w15="http://schemas.microsoft.com/office/word/2012/wordml" xmlns:w16cex="http://schemas.microsoft.com/office/word/2018/wordml/cex" xmlns:w16cid="http://schemas.microsoft.com/office/word/2016/wordml/cid" xmlns:w16="http://schemas.microsoft.com/office/word/2018/wordml" xmlns:w16se="http://schemas.microsoft.com/office/word/2015/wordml/symex" xmlns:wpg="http://schemas.microsoft.com/office/word/2010/wordprocessingGroup" xmlns:wpi="http://schemas.microsoft.com/office/word/2010/wordprocessingInk" xmlns:wne="http://schemas.microsoft.com/office/word/2006/wordml" xmlns:wps="http://schemas.microsoft.com/office/word/2010/wordprocessingShape" xmlns="" xmlns:mo="http://schemas.microsoft.com/office/mac/office/2008/main" xmlns:mv="urn:schemas-microsoft-com:mac:vml" xmlns:o="urn:schemas-microsoft-com:office:office" xmlns:v="urn:schemas-microsoft-com:vml" xmlns:w10="urn:schemas-microsoft-com:office:word" xmlns:w="http://schemas.openxmlformats.org/wordprocessingml/2006/main" xmlns:a14="http://schemas.microsoft.com/office/drawing/2010/main" xmlns:lc="http://schemas.openxmlformats.org/drawingml/2006/lockedCanvas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7" name="Abgerundetes Rechteck 31">
              <a:extLst>
                <a:ext uri="{FF2B5EF4-FFF2-40B4-BE49-F238E27FC236}">
                  <a16:creationId xmlns:a16="http://schemas.microsoft.com/office/drawing/2014/main" id="{2CE9F357-E5C2-6F88-C2EF-F8FF3FB273DD}"/>
                </a:ext>
              </a:extLst>
            </p:cNvPr>
            <p:cNvSpPr/>
            <p:nvPr/>
          </p:nvSpPr>
          <p:spPr>
            <a:xfrm>
              <a:off x="579615" y="5796075"/>
              <a:ext cx="2439040" cy="447590"/>
            </a:xfrm>
            <a:prstGeom prst="round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>
              <a:noAutofit/>
            </a:bodyPr>
            <a:lstStyle/>
            <a:p>
              <a:pPr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initial aneurysm diameter &lt;30mm or &gt;49mm (n=11)</a:t>
              </a:r>
              <a:endParaRPr lang="de-DE" sz="1200" dirty="0">
                <a:solidFill>
                  <a:prstClr val="white"/>
                </a:solidFill>
                <a:latin typeface="Times New Roman" panose="02020603050405020304" pitchFamily="18" charset="0"/>
                <a:ea typeface="MS Mincho" panose="02020609040205080304" pitchFamily="49" charset="-128"/>
              </a:endParaRPr>
            </a:p>
          </p:txBody>
        </p:sp>
        <p:sp>
          <p:nvSpPr>
            <p:cNvPr id="38" name="Abgerundetes Rechteck 17">
              <a:extLst>
                <a:ext uri="{FF2B5EF4-FFF2-40B4-BE49-F238E27FC236}">
                  <a16:creationId xmlns:a16="http://schemas.microsoft.com/office/drawing/2014/main" id="{4EBF4C7B-704F-08AF-A110-E118C9B19AB1}"/>
                </a:ext>
              </a:extLst>
            </p:cNvPr>
            <p:cNvSpPr/>
            <p:nvPr/>
          </p:nvSpPr>
          <p:spPr>
            <a:xfrm>
              <a:off x="16268" y="6290943"/>
              <a:ext cx="3567291" cy="551427"/>
            </a:xfrm>
            <a:prstGeom prst="roundRect">
              <a:avLst/>
            </a:prstGeom>
            <a:solidFill>
              <a:schemeClr val="bg2">
                <a:lumMod val="9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/>
            <a:lstStyle/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well-documented RT</a:t>
              </a:r>
            </a:p>
            <a:p>
              <a:pPr algn="ctr" defTabSz="457200" eaLnBrk="0" fontAlgn="base" hangingPunct="0"/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n = 27 </a:t>
              </a:r>
              <a:r>
                <a:rPr lang="en-US" sz="1200" i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AAA + cancer + RT 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(</a:t>
              </a:r>
              <a:r>
                <a:rPr lang="en-US" sz="1200" b="1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Table 1-4</a:t>
              </a:r>
              <a:r>
                <a:rPr lang="en-US" sz="1200" dirty="0">
                  <a:solidFill>
                    <a:srgbClr val="000000"/>
                  </a:solidFill>
                  <a:latin typeface="Arial" panose="020B0604020202020204" pitchFamily="34" charset="0"/>
                  <a:ea typeface="MS Mincho" panose="02020609040205080304" pitchFamily="49" charset="-128"/>
                </a:rPr>
                <a:t>)</a:t>
              </a:r>
            </a:p>
          </p:txBody>
        </p:sp>
      </p:grpSp>
      <p:sp>
        <p:nvSpPr>
          <p:cNvPr id="3" name="Textfeld 2">
            <a:extLst>
              <a:ext uri="{FF2B5EF4-FFF2-40B4-BE49-F238E27FC236}">
                <a16:creationId xmlns:a16="http://schemas.microsoft.com/office/drawing/2014/main" id="{A822CC73-B1F4-FBA1-6F59-7DC4BB3B8141}"/>
              </a:ext>
            </a:extLst>
          </p:cNvPr>
          <p:cNvSpPr txBox="1"/>
          <p:nvPr/>
        </p:nvSpPr>
        <p:spPr>
          <a:xfrm>
            <a:off x="5321144" y="209889"/>
            <a:ext cx="6096000" cy="4776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Flow chart of patient identification, inclusion criteria, and group comparisons.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ld double arrows indicate statistical inter-group analyses.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7786580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ieren 3">
            <a:extLst>
              <a:ext uri="{FF2B5EF4-FFF2-40B4-BE49-F238E27FC236}">
                <a16:creationId xmlns:a16="http://schemas.microsoft.com/office/drawing/2014/main" id="{9D8ABD22-B57B-FE33-6662-88CAE5F67D65}"/>
              </a:ext>
            </a:extLst>
          </p:cNvPr>
          <p:cNvGrpSpPr/>
          <p:nvPr/>
        </p:nvGrpSpPr>
        <p:grpSpPr>
          <a:xfrm>
            <a:off x="-2" y="-72851"/>
            <a:ext cx="12192001" cy="3783435"/>
            <a:chOff x="-2" y="-72851"/>
            <a:chExt cx="12192001" cy="3783435"/>
          </a:xfrm>
        </p:grpSpPr>
        <p:pic>
          <p:nvPicPr>
            <p:cNvPr id="5" name="Grafik 4" descr="Ein Bild, das Text enthält.&#10;&#10;Automatisch generierte Beschreibung">
              <a:extLst>
                <a:ext uri="{FF2B5EF4-FFF2-40B4-BE49-F238E27FC236}">
                  <a16:creationId xmlns:a16="http://schemas.microsoft.com/office/drawing/2014/main" id="{17FAF34E-B149-4383-E32B-A4D0D3752BF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" y="0"/>
              <a:ext cx="6265719" cy="3710584"/>
            </a:xfrm>
            <a:prstGeom prst="rect">
              <a:avLst/>
            </a:prstGeom>
          </p:spPr>
        </p:pic>
        <p:pic>
          <p:nvPicPr>
            <p:cNvPr id="6" name="Grafik 5" descr="Ein Bild, das Text enthält.&#10;&#10;Automatisch generierte Beschreibung">
              <a:extLst>
                <a:ext uri="{FF2B5EF4-FFF2-40B4-BE49-F238E27FC236}">
                  <a16:creationId xmlns:a16="http://schemas.microsoft.com/office/drawing/2014/main" id="{C8EB72B4-3BCC-1A51-DB40-CB71C25E2E2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34411" y="0"/>
              <a:ext cx="5857588" cy="3710584"/>
            </a:xfrm>
            <a:prstGeom prst="rect">
              <a:avLst/>
            </a:prstGeom>
          </p:spPr>
        </p:pic>
        <p:cxnSp>
          <p:nvCxnSpPr>
            <p:cNvPr id="7" name="Gerade Verbindung mit Pfeil 6">
              <a:extLst>
                <a:ext uri="{FF2B5EF4-FFF2-40B4-BE49-F238E27FC236}">
                  <a16:creationId xmlns:a16="http://schemas.microsoft.com/office/drawing/2014/main" id="{EF02EAB8-BEF8-FE6D-0232-48F5072C7B7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421587" y="820882"/>
              <a:ext cx="319600" cy="372932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 Verbindung mit Pfeil 7">
              <a:extLst>
                <a:ext uri="{FF2B5EF4-FFF2-40B4-BE49-F238E27FC236}">
                  <a16:creationId xmlns:a16="http://schemas.microsoft.com/office/drawing/2014/main" id="{F9218DDE-3F2D-4037-4632-E813DA0D4EB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4451268" y="2147455"/>
              <a:ext cx="319600" cy="372932"/>
            </a:xfrm>
            <a:prstGeom prst="straightConnector1">
              <a:avLst/>
            </a:prstGeom>
            <a:ln w="12700">
              <a:solidFill>
                <a:schemeClr val="bg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feld 8">
              <a:extLst>
                <a:ext uri="{FF2B5EF4-FFF2-40B4-BE49-F238E27FC236}">
                  <a16:creationId xmlns:a16="http://schemas.microsoft.com/office/drawing/2014/main" id="{5911226D-7C81-EE58-E0D9-D9675BC2E1EF}"/>
                </a:ext>
              </a:extLst>
            </p:cNvPr>
            <p:cNvSpPr txBox="1"/>
            <p:nvPr/>
          </p:nvSpPr>
          <p:spPr>
            <a:xfrm>
              <a:off x="5857590" y="-72851"/>
              <a:ext cx="1678329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000" b="1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10" name="Textfeld 9">
              <a:extLst>
                <a:ext uri="{FF2B5EF4-FFF2-40B4-BE49-F238E27FC236}">
                  <a16:creationId xmlns:a16="http://schemas.microsoft.com/office/drawing/2014/main" id="{45DB4177-10C1-221D-006F-EAF251647079}"/>
                </a:ext>
              </a:extLst>
            </p:cNvPr>
            <p:cNvSpPr txBox="1"/>
            <p:nvPr/>
          </p:nvSpPr>
          <p:spPr>
            <a:xfrm>
              <a:off x="11780026" y="-72851"/>
              <a:ext cx="343283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3000" b="1" dirty="0">
                  <a:solidFill>
                    <a:schemeClr val="bg1"/>
                  </a:solidFill>
                </a:rPr>
                <a:t>b</a:t>
              </a:r>
            </a:p>
          </p:txBody>
        </p:sp>
      </p:grpSp>
      <p:sp>
        <p:nvSpPr>
          <p:cNvPr id="12" name="Textfeld 11">
            <a:extLst>
              <a:ext uri="{FF2B5EF4-FFF2-40B4-BE49-F238E27FC236}">
                <a16:creationId xmlns:a16="http://schemas.microsoft.com/office/drawing/2014/main" id="{BEDE7438-DD56-721F-9754-BEDBBC0D222B}"/>
              </a:ext>
            </a:extLst>
          </p:cNvPr>
          <p:cNvSpPr txBox="1"/>
          <p:nvPr/>
        </p:nvSpPr>
        <p:spPr>
          <a:xfrm>
            <a:off x="3189142" y="4210725"/>
            <a:ext cx="6153150" cy="12654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Dose color wash of radiation with contouring and relative radiation exposure of an infield AAA. 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The radiation field was vertebrae TH12-S1 for meningeal carcinomatosis in a patient with lung cancer. Target dose was 45Gy (25x1.8Gy). Arrows denote AAA location, highlighted (i.e., contoured) with a yellow frame. Mean AAA radiation exposure was calculated to be 3.8Gy. 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a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sagittal view 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b</a:t>
            </a:r>
            <a:r>
              <a:rPr lang="en-US" sz="12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transversal view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06663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ieren 8">
            <a:extLst>
              <a:ext uri="{FF2B5EF4-FFF2-40B4-BE49-F238E27FC236}">
                <a16:creationId xmlns:a16="http://schemas.microsoft.com/office/drawing/2014/main" id="{422E5C18-FA4D-45C3-068D-140818E13CAF}"/>
              </a:ext>
            </a:extLst>
          </p:cNvPr>
          <p:cNvGrpSpPr/>
          <p:nvPr/>
        </p:nvGrpSpPr>
        <p:grpSpPr>
          <a:xfrm>
            <a:off x="514350" y="361950"/>
            <a:ext cx="10796038" cy="3599695"/>
            <a:chOff x="0" y="0"/>
            <a:chExt cx="10796038" cy="3599695"/>
          </a:xfrm>
        </p:grpSpPr>
        <p:pic>
          <p:nvPicPr>
            <p:cNvPr id="10" name="Grafik 9">
              <a:extLst>
                <a:ext uri="{FF2B5EF4-FFF2-40B4-BE49-F238E27FC236}">
                  <a16:creationId xmlns:a16="http://schemas.microsoft.com/office/drawing/2014/main" id="{8A0F4E1C-E9B4-B81B-FD56-20C50BB70DD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8019" y="0"/>
              <a:ext cx="5398019" cy="3599695"/>
            </a:xfrm>
            <a:prstGeom prst="rect">
              <a:avLst/>
            </a:prstGeom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5EDF3B2B-713E-09C9-9AE7-D97366A3B63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0"/>
              <a:ext cx="5398019" cy="3599695"/>
            </a:xfrm>
            <a:prstGeom prst="rect">
              <a:avLst/>
            </a:prstGeom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45ABED5F-0462-CDD1-50AF-3F4A88F8C43D}"/>
                </a:ext>
              </a:extLst>
            </p:cNvPr>
            <p:cNvSpPr txBox="1"/>
            <p:nvPr/>
          </p:nvSpPr>
          <p:spPr>
            <a:xfrm>
              <a:off x="366396" y="84086"/>
              <a:ext cx="59836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/>
                <a:t>a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B96545A1-AEEA-D121-EE18-6DE538988EBC}"/>
                </a:ext>
              </a:extLst>
            </p:cNvPr>
            <p:cNvSpPr txBox="1"/>
            <p:nvPr/>
          </p:nvSpPr>
          <p:spPr>
            <a:xfrm>
              <a:off x="5764415" y="84086"/>
              <a:ext cx="62407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b="1" dirty="0"/>
                <a:t>b</a:t>
              </a:r>
            </a:p>
          </p:txBody>
        </p:sp>
      </p:grpSp>
      <p:sp>
        <p:nvSpPr>
          <p:cNvPr id="15" name="Textfeld 14">
            <a:extLst>
              <a:ext uri="{FF2B5EF4-FFF2-40B4-BE49-F238E27FC236}">
                <a16:creationId xmlns:a16="http://schemas.microsoft.com/office/drawing/2014/main" id="{D6EE8D2E-3DB0-B190-7AD5-5B97C9549F79}"/>
              </a:ext>
            </a:extLst>
          </p:cNvPr>
          <p:cNvSpPr txBox="1"/>
          <p:nvPr/>
        </p:nvSpPr>
        <p:spPr>
          <a:xfrm>
            <a:off x="3230765" y="4605851"/>
            <a:ext cx="6096000" cy="15653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Linear regression analyses correcting for initial AAA diameter on the influence of radiation dosage on annual AAA growth rates. </a:t>
            </a:r>
            <a:b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</a:b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 individual (each dot = one patient) growth rate (y-axis) depending on the initial diameter (x-axis) is plotted on the graph, while the individual radiation dose is given as color scheme. 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The line represents the result from a linear regression for AAA growth depending on initial diameter. Given are the values of the estimator (est.) for the influence of radiation dosage on AAA growth and the respective p-values after correction for initial diameter. </a:t>
            </a:r>
            <a:r>
              <a:rPr lang="en-US" sz="1100" b="1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a</a:t>
            </a:r>
            <a:r>
              <a:rPr lang="en-US" sz="1100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 </a:t>
            </a:r>
            <a:r>
              <a:rPr lang="en-US" sz="1100" dirty="0" err="1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meanGy</a:t>
            </a:r>
            <a:r>
              <a:rPr lang="en-US" sz="1100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: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.=-0.02mm/y, p=0.34 </a:t>
            </a:r>
            <a:r>
              <a:rPr lang="en-US" sz="1100" b="1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b</a:t>
            </a:r>
            <a:r>
              <a:rPr lang="en-US" sz="1100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 </a:t>
            </a:r>
            <a:r>
              <a:rPr lang="en-US" sz="1100" dirty="0" err="1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maxGy</a:t>
            </a:r>
            <a:r>
              <a:rPr lang="en-US" sz="1100" dirty="0">
                <a:effectLst/>
                <a:latin typeface="Arial" panose="020B0604020202020204" pitchFamily="34" charset="0"/>
                <a:ea typeface="MS Mincho" panose="02020609040205080304" pitchFamily="49" charset="-128"/>
              </a:rPr>
              <a:t>: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est.=-0.01mm/y, p=0.41</a:t>
            </a:r>
            <a:endParaRPr lang="de-DE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55094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5</Words>
  <Application>Microsoft Office PowerPoint</Application>
  <PresentationFormat>Breitbild</PresentationFormat>
  <Paragraphs>36</Paragraphs>
  <Slides>3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2</vt:i4>
      </vt:variant>
      <vt:variant>
        <vt:lpstr>Folientitel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</vt:lpstr>
      <vt:lpstr>1_Office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BvR</dc:creator>
  <cp:lastModifiedBy>ABvR</cp:lastModifiedBy>
  <cp:revision>2</cp:revision>
  <dcterms:created xsi:type="dcterms:W3CDTF">2023-05-26T19:16:23Z</dcterms:created>
  <dcterms:modified xsi:type="dcterms:W3CDTF">2023-07-26T16:45:55Z</dcterms:modified>
</cp:coreProperties>
</file>